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9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1"/>
    <p:restoredTop sz="94694"/>
  </p:normalViewPr>
  <p:slideViewPr>
    <p:cSldViewPr snapToGrid="0">
      <p:cViewPr varScale="1">
        <p:scale>
          <a:sx n="121" d="100"/>
          <a:sy n="121" d="100"/>
        </p:scale>
        <p:origin x="73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C503C8-CF43-7193-C734-A702C2979F1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201F7EA-CF86-D2D8-B17F-29AD3FDBE6A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EEE8BD-2701-E146-9192-7E670C6274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BA02E-7079-DD4F-B425-8DF459B256EA}" type="datetimeFigureOut">
              <a:rPr lang="en-US" smtClean="0"/>
              <a:t>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F6CFF2-292E-85A7-858E-55484A5BC6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E61F13-1863-FB74-F4C9-499385FDBE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8780F-4856-F841-AE92-C5270E7B0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7680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47ABBF-F8B3-450F-19F0-043174C184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0945B1-1222-8C9E-A74F-15C241844D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D973BD-2D2F-CA09-CCBE-C64A3C06F0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BA02E-7079-DD4F-B425-8DF459B256EA}" type="datetimeFigureOut">
              <a:rPr lang="en-US" smtClean="0"/>
              <a:t>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64CDB4-5F1C-FB08-83D3-483F32D1B6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7BC647-4C2F-9A43-CA83-568F468CA5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8780F-4856-F841-AE92-C5270E7B0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673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033F19D-AF64-FFFD-82B8-DA130B8F70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B400F3-28B5-15AB-8838-C7256CDB42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10633D-F72C-42A3-A813-3129D92168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BA02E-7079-DD4F-B425-8DF459B256EA}" type="datetimeFigureOut">
              <a:rPr lang="en-US" smtClean="0"/>
              <a:t>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E71F54-4B76-B0E0-F33B-E6ECDC85A6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EDB23E-A9A2-82D0-FA2E-7EBEECA4D6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8780F-4856-F841-AE92-C5270E7B0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7304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599622-5436-5E5A-E685-B607EE0BD2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306476-B9EB-B44A-6E12-80DCBDE16CF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80325D-CAD7-82A3-FB22-C4EA42C181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BA02E-7079-DD4F-B425-8DF459B256EA}" type="datetimeFigureOut">
              <a:rPr lang="en-US" smtClean="0"/>
              <a:t>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9E8877-AC7E-E9F9-E14D-454166D376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395244-D3C7-E52F-E879-1115A08310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8780F-4856-F841-AE92-C5270E7B0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3545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E58216-7A0A-A1B0-7798-B4B4DEA8C5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6B6ADB-B260-127A-1699-219A9CE202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20E7C2-7CB2-184A-8AC3-7C29EAD2DF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BA02E-7079-DD4F-B425-8DF459B256EA}" type="datetimeFigureOut">
              <a:rPr lang="en-US" smtClean="0"/>
              <a:t>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40A53D-4D03-5983-CE7D-537EF2491E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F1D00B-3187-130A-C050-1D04A949E4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8780F-4856-F841-AE92-C5270E7B0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13064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FB5EE3-8701-3C6F-4E1D-8D4E780F4B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95C706-A71E-D5BD-9B21-4F7420F120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D36839-77EA-E1FC-F6ED-C7812CB765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A24DCB-1CA8-ABF9-0864-BE1380A894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BA02E-7079-DD4F-B425-8DF459B256EA}" type="datetimeFigureOut">
              <a:rPr lang="en-US" smtClean="0"/>
              <a:t>2/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859F1E-6D81-4460-7953-E2303EA72B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DA02AB-0D7E-0773-4121-32E9F4C454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8780F-4856-F841-AE92-C5270E7B0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0589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6EC500-4106-7903-DD9F-35255A8D96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AC18A9-C0F2-B4EC-AA6A-19F1F946A8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22022A-7030-44B9-8D55-2783919108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11254BC-608B-997D-97C3-DC13BEDCA6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0CA49BF-496F-0CA9-D731-9BF28F0708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6D129C9-CAEC-5A6F-CD9C-A003533D34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BA02E-7079-DD4F-B425-8DF459B256EA}" type="datetimeFigureOut">
              <a:rPr lang="en-US" smtClean="0"/>
              <a:t>2/5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D20477A-55EF-A504-5EB7-04C85BF95E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808724-A18C-04E1-3197-D46DF4F77C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8780F-4856-F841-AE92-C5270E7B0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106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145F70-AC37-F369-D334-8ADB0360BB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9F5568E-04CC-2739-E853-5052F3DD27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BA02E-7079-DD4F-B425-8DF459B256EA}" type="datetimeFigureOut">
              <a:rPr lang="en-US" smtClean="0"/>
              <a:t>2/5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BFBA901-DCB9-CC78-2603-DE8BBF4C71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0493C9A-95DA-3605-CBF8-5562C31447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8780F-4856-F841-AE92-C5270E7B0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8450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06901A9-5BB4-5186-4321-DA92B51F40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BA02E-7079-DD4F-B425-8DF459B256EA}" type="datetimeFigureOut">
              <a:rPr lang="en-US" smtClean="0"/>
              <a:t>2/5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C38BDA2-9000-43FA-F131-965E1ADAEF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F55A4E9-B341-3648-206D-52CBE11281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8780F-4856-F841-AE92-C5270E7B0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731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B6543F-A3D9-BAFE-7879-290F7A7292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11C41D-3764-CEB5-367B-BD89AA9E84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62B845-10B3-6B77-1A0D-3A85BBBAD4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E588D7-F0D8-A8D1-C804-B24916E7FB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BA02E-7079-DD4F-B425-8DF459B256EA}" type="datetimeFigureOut">
              <a:rPr lang="en-US" smtClean="0"/>
              <a:t>2/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C72B3C-F02F-9457-1B08-BE9F95E3B0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3F52DA-1443-8EE7-43FE-992F20532E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8780F-4856-F841-AE92-C5270E7B0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7283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064DBD-70EC-9A4B-9A27-162DD6CF04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445E8AC-F003-C0FD-0A72-7F46373AC3E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5D5692E-A968-2B6C-E03A-816DA8E445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278684-D9CE-B7E1-3BAA-1D8184EE67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BA02E-7079-DD4F-B425-8DF459B256EA}" type="datetimeFigureOut">
              <a:rPr lang="en-US" smtClean="0"/>
              <a:t>2/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08F28D-2B4F-F293-BCA2-7CAD06335B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B7D0C1-BA42-9656-85F8-7A665D9F10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08780F-4856-F841-AE92-C5270E7B0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1845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1627149-2458-173D-B2F8-5502CDBB2C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9CAC95-2E92-275F-1C2D-33F9D4C922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4B707C-39C5-1B49-4919-E7B1C902D6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7EBA02E-7079-DD4F-B425-8DF459B256EA}" type="datetimeFigureOut">
              <a:rPr lang="en-US" smtClean="0"/>
              <a:t>2/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1E9743-2A8B-2887-266A-F2C25E746E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9F7782-A156-D921-CC63-6D8C873502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A08780F-4856-F841-AE92-C5270E7B0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822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415797B-320B-9D89-6CED-8A2C342C9411}"/>
              </a:ext>
            </a:extLst>
          </p:cNvPr>
          <p:cNvSpPr txBox="1"/>
          <p:nvPr/>
        </p:nvSpPr>
        <p:spPr>
          <a:xfrm>
            <a:off x="1394058" y="4140565"/>
            <a:ext cx="94946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1. </a:t>
            </a:r>
            <a:r>
              <a:rPr lang="en-US" b="1" i="1" dirty="0"/>
              <a:t>A</a:t>
            </a:r>
            <a:r>
              <a:rPr lang="en-US" dirty="0"/>
              <a:t>.</a:t>
            </a:r>
            <a:r>
              <a:rPr lang="en-US" b="1" dirty="0"/>
              <a:t> </a:t>
            </a:r>
            <a:r>
              <a:rPr lang="en-US" dirty="0"/>
              <a:t>Similarity of dependence of readthrough on ataluren concentration for different mutant sequences. </a:t>
            </a:r>
            <a:r>
              <a:rPr lang="en-US" b="1" i="1" dirty="0"/>
              <a:t>B. </a:t>
            </a:r>
            <a:r>
              <a:rPr lang="en-US" dirty="0"/>
              <a:t>Parameter values.</a:t>
            </a:r>
          </a:p>
        </p:txBody>
      </p:sp>
      <p:pic>
        <p:nvPicPr>
          <p:cNvPr id="8" name="Picture 7" descr="e4.jpg"/>
          <p:cNvPicPr>
            <a:picLocks noChangeAspect="1"/>
          </p:cNvPicPr>
          <p:nvPr/>
        </p:nvPicPr>
        <p:blipFill>
          <a:blip r:embed="rId2"/>
          <a:srcRect l="3559" t="13481" r="4315" b="2776"/>
          <a:stretch>
            <a:fillRect/>
          </a:stretch>
        </p:blipFill>
        <p:spPr>
          <a:xfrm>
            <a:off x="972410" y="975334"/>
            <a:ext cx="3764388" cy="326370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F1632B5-BEB2-04B4-26B2-84C1949B000E}"/>
              </a:ext>
            </a:extLst>
          </p:cNvPr>
          <p:cNvSpPr txBox="1"/>
          <p:nvPr/>
        </p:nvSpPr>
        <p:spPr>
          <a:xfrm>
            <a:off x="7652952" y="2666647"/>
            <a:ext cx="44743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18A8CA13-CA00-E375-D6E4-C9668CBD6093}"/>
              </a:ext>
            </a:extLst>
          </p:cNvPr>
          <p:cNvGraphicFramePr>
            <a:graphicFrameLocks noGrp="1"/>
          </p:cNvGraphicFramePr>
          <p:nvPr/>
        </p:nvGraphicFramePr>
        <p:xfrm>
          <a:off x="5339842" y="918788"/>
          <a:ext cx="5548876" cy="270988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07922">
                  <a:extLst>
                    <a:ext uri="{9D8B030D-6E8A-4147-A177-3AD203B41FA5}">
                      <a16:colId xmlns:a16="http://schemas.microsoft.com/office/drawing/2014/main" val="3320586570"/>
                    </a:ext>
                  </a:extLst>
                </a:gridCol>
                <a:gridCol w="1406353">
                  <a:extLst>
                    <a:ext uri="{9D8B030D-6E8A-4147-A177-3AD203B41FA5}">
                      <a16:colId xmlns:a16="http://schemas.microsoft.com/office/drawing/2014/main" val="1577145916"/>
                    </a:ext>
                  </a:extLst>
                </a:gridCol>
                <a:gridCol w="1320250">
                  <a:extLst>
                    <a:ext uri="{9D8B030D-6E8A-4147-A177-3AD203B41FA5}">
                      <a16:colId xmlns:a16="http://schemas.microsoft.com/office/drawing/2014/main" val="3959683950"/>
                    </a:ext>
                  </a:extLst>
                </a:gridCol>
                <a:gridCol w="997580">
                  <a:extLst>
                    <a:ext uri="{9D8B030D-6E8A-4147-A177-3AD203B41FA5}">
                      <a16:colId xmlns:a16="http://schemas.microsoft.com/office/drawing/2014/main" val="77541917"/>
                    </a:ext>
                  </a:extLst>
                </a:gridCol>
                <a:gridCol w="1316771">
                  <a:extLst>
                    <a:ext uri="{9D8B030D-6E8A-4147-A177-3AD203B41FA5}">
                      <a16:colId xmlns:a16="http://schemas.microsoft.com/office/drawing/2014/main" val="1304002995"/>
                    </a:ext>
                  </a:extLst>
                </a:gridCol>
              </a:tblGrid>
              <a:tr h="97559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#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30" marR="62230" marT="9525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Stop-POST5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30" marR="62230" marT="9525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EC</a:t>
                      </a:r>
                      <a:r>
                        <a:rPr lang="en-US" sz="1200" kern="100" baseline="-25000" dirty="0">
                          <a:effectLst/>
                        </a:rPr>
                        <a:t>50</a:t>
                      </a:r>
                      <a:r>
                        <a:rPr lang="en-US" sz="1200" kern="100" baseline="30000" dirty="0">
                          <a:effectLst/>
                        </a:rPr>
                        <a:t>Ata</a:t>
                      </a:r>
                      <a:r>
                        <a:rPr lang="en-US" sz="1200" kern="100" dirty="0">
                          <a:effectLst/>
                        </a:rPr>
                        <a:t>,</a:t>
                      </a:r>
                      <a:r>
                        <a:rPr lang="en-US" sz="1200" kern="100" baseline="30000" dirty="0">
                          <a:effectLst/>
                        </a:rPr>
                        <a:t> </a:t>
                      </a:r>
                      <a:r>
                        <a:rPr lang="en-IN" sz="1200" kern="100" dirty="0">
                          <a:effectLst/>
                        </a:rPr>
                        <a:t>m</a:t>
                      </a:r>
                      <a:r>
                        <a:rPr lang="en-US" sz="1200" kern="100" dirty="0">
                          <a:effectLst/>
                        </a:rPr>
                        <a:t>M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30" marR="62230" marT="9525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Hill n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30" marR="62230" marT="9525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IN" sz="1200" kern="100" dirty="0">
                        <a:effectLst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kern="100">
                          <a:effectLst/>
                        </a:rPr>
                        <a:t>PRE6/POST5</a:t>
                      </a:r>
                      <a:endParaRPr lang="en-US" sz="1200" kern="100" dirty="0">
                        <a:effectLst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69105048"/>
                  </a:ext>
                </a:extLst>
              </a:tr>
              <a:tr h="34213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1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30" marR="62230" marT="9525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Reference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30" marR="62230" marT="9525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kern="100">
                          <a:effectLst/>
                        </a:rPr>
                        <a:t>0.32 ± 0.02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30" marR="62230" marT="9525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</a:rPr>
                        <a:t>3.6 ± 0.5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30" marR="62230" marT="9525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200" kern="100" dirty="0">
                          <a:effectLst/>
                        </a:rPr>
                        <a:t> 24 ±</a:t>
                      </a:r>
                      <a:r>
                        <a:rPr lang="en-IN" sz="1200" kern="100" baseline="0" dirty="0">
                          <a:effectLst/>
                        </a:rPr>
                        <a:t> </a:t>
                      </a:r>
                      <a:r>
                        <a:rPr lang="en-IN" sz="1200" kern="100" dirty="0">
                          <a:effectLst/>
                        </a:rPr>
                        <a:t>5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624921801"/>
                  </a:ext>
                </a:extLst>
              </a:tr>
              <a:tr h="34213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2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30" marR="62230" marT="9525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CF-S466X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30" marR="62230" marT="9525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kern="100">
                          <a:effectLst/>
                        </a:rPr>
                        <a:t>0.29 ± 0.07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30" marR="62230" marT="9525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kern="100">
                          <a:effectLst/>
                        </a:rPr>
                        <a:t>2.8 ± 0.2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30" marR="62230" marT="9525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</a:rPr>
                        <a:t> 25 ±</a:t>
                      </a:r>
                      <a:r>
                        <a:rPr lang="en-IN" sz="1200" kern="100" baseline="0" dirty="0">
                          <a:effectLst/>
                        </a:rPr>
                        <a:t> 6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629232155"/>
                  </a:ext>
                </a:extLst>
              </a:tr>
              <a:tr h="34213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3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30" marR="62230" marT="9525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CF-Y1092X</a:t>
                      </a:r>
                      <a:r>
                        <a:rPr lang="en-US" sz="1200" kern="100" cap="all" baseline="30000" dirty="0">
                          <a:effectLst/>
                        </a:rPr>
                        <a:t>A</a:t>
                      </a:r>
                      <a:r>
                        <a:rPr lang="en-US" sz="1200" kern="100" dirty="0">
                          <a:effectLst/>
                        </a:rPr>
                        <a:t>*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30" marR="62230" marT="9525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kern="100">
                          <a:effectLst/>
                        </a:rPr>
                        <a:t>0.33 ± 0.04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30" marR="62230" marT="9525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kern="100">
                          <a:effectLst/>
                        </a:rPr>
                        <a:t>2.9 ± 0.3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30" marR="62230" marT="9525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</a:rPr>
                        <a:t> 33 ±</a:t>
                      </a:r>
                      <a:r>
                        <a:rPr lang="en-IN" sz="1200" kern="100" baseline="0" dirty="0">
                          <a:effectLst/>
                        </a:rPr>
                        <a:t> 6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142457209"/>
                  </a:ext>
                </a:extLst>
              </a:tr>
              <a:tr h="34213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4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30" marR="62230" marT="9525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FB-R516X*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30" marR="62230" marT="9525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kern="100">
                          <a:effectLst/>
                        </a:rPr>
                        <a:t>0.29 ± 0.03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30" marR="62230" marT="9525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kern="100">
                          <a:effectLst/>
                        </a:rPr>
                        <a:t>3.1± 0.2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30" marR="62230" marT="9525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</a:rPr>
                        <a:t> 8.5 ±</a:t>
                      </a:r>
                      <a:r>
                        <a:rPr lang="en-IN" sz="1200" kern="100" baseline="0" dirty="0">
                          <a:effectLst/>
                        </a:rPr>
                        <a:t> 2.3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389295113"/>
                  </a:ext>
                </a:extLst>
              </a:tr>
              <a:tr h="342134">
                <a:tc gridSpan="5"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200" kern="100" dirty="0">
                          <a:effectLst/>
                        </a:rPr>
                        <a:t>Stop-POST5,  0.05 µM; RFC, 0.05 µM; </a:t>
                      </a:r>
                      <a:r>
                        <a:rPr lang="en-IN" sz="1200" kern="100" dirty="0" err="1">
                          <a:effectLst/>
                        </a:rPr>
                        <a:t>Trp</a:t>
                      </a:r>
                      <a:r>
                        <a:rPr lang="en-IN" sz="1200" kern="100" dirty="0">
                          <a:effectLst/>
                        </a:rPr>
                        <a:t>-TC 0.2 µM.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230" marR="62230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97366738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DCFCB97D-A058-A3F9-018F-A66DD67313B3}"/>
              </a:ext>
            </a:extLst>
          </p:cNvPr>
          <p:cNvSpPr txBox="1"/>
          <p:nvPr/>
        </p:nvSpPr>
        <p:spPr>
          <a:xfrm>
            <a:off x="691055" y="901147"/>
            <a:ext cx="49424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                                                                                                B            </a:t>
            </a:r>
          </a:p>
        </p:txBody>
      </p:sp>
    </p:spTree>
    <p:extLst>
      <p:ext uri="{BB962C8B-B14F-4D97-AF65-F5344CB8AC3E}">
        <p14:creationId xmlns:p14="http://schemas.microsoft.com/office/powerpoint/2010/main" val="19628734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00</Words>
  <Application>Microsoft Macintosh PowerPoint</Application>
  <PresentationFormat>Widescreen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ooperman, Barry S</dc:creator>
  <cp:lastModifiedBy>Cooperman, Barry S</cp:lastModifiedBy>
  <cp:revision>1</cp:revision>
  <dcterms:created xsi:type="dcterms:W3CDTF">2025-02-05T16:42:52Z</dcterms:created>
  <dcterms:modified xsi:type="dcterms:W3CDTF">2025-02-05T16:44:05Z</dcterms:modified>
</cp:coreProperties>
</file>